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90"/>
    <p:restoredTop sz="94646"/>
  </p:normalViewPr>
  <p:slideViewPr>
    <p:cSldViewPr snapToGrid="0">
      <p:cViewPr varScale="1">
        <p:scale>
          <a:sx n="103" d="100"/>
          <a:sy n="103" d="100"/>
        </p:scale>
        <p:origin x="8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60DDC-F05F-D140-C495-E866B153FD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4EE05B-CBAF-C2E0-91A0-B9593C0C5F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A218B1-08B5-C246-DD18-D0A7AFCB9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B817E4-D69E-17CC-51F9-727D768AE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D3A61-3423-6A9D-07B0-6661A86CF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0499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6D458-26F0-0C54-7E05-35611CC31E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6B3D45-25F9-33BF-C026-3934E2A0B5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791E0B-DB1D-E289-CA57-FADE0727D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17CBE0-ABEF-D445-7B02-AD1388608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27FFAC-BB0D-92A7-973B-13EDADC98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7979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1AD7D0-103A-708E-ABEF-4850BB1578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10A59C-9AFD-743F-6716-DFA3C3E178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E3E94D-A3C3-82BF-F5B1-8B0092FB0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A0DE2-6879-585E-8EA8-9E3D3DC7B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8BF789-52AF-789F-D2E6-521443947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7305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0DEE0-A40C-7B25-3757-74B072AA1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E0C881-C490-514D-C144-C23196A628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12E2EF-C925-BC7F-EA68-98060D840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141B2-D541-F4F7-B026-940ACE249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F43D93-C597-38A2-DF87-64FA41FD6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273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5C2ABA-58A1-5724-FB06-66DE5DB9FE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DD55BB-8301-1629-ABEF-0467D7AF79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D7A29E-0B58-E137-0A4E-5FE39BA29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9CE48B-7C5F-04D6-8E25-DDDFAAD31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571D00-305F-F7D9-C03D-02CC2BAE9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50437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528CD-A718-0C5F-9009-5AEDFE8203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F62C79-FD3C-5432-EA15-8112FC975B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BE0ACF-08C5-AADA-6D4A-E753D83ACE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C364AB-9342-1D31-A4B2-0B8B15133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F70194-1F70-3611-DC4D-D2C5A9961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FFE0F3-47CD-672D-99B3-BC6E61D1D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6354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208B1-F0DB-7B63-F85E-5EDD5700F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35C472-E03A-6057-CFDD-3D26147E85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DBF5A0-F40E-1DC6-2C66-2A26E831BE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FEFF1F4-9F85-4E30-6EDB-AD3F5D68BA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AF982D-E30B-469B-B05C-4EE3B89E1E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4A2D58-0F66-251F-7163-4F8214574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E8E71C-9C64-A7CC-E0BD-094F18CC4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5ADF30-A341-04DD-D579-277E65FB6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6298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D7DFDF-F31B-C61E-3E97-80E86F505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2C944C-6D55-9F31-5C91-1BAADC9CE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D0F8AE-5DD0-453A-629E-6706535A1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99BB9B-A82E-BA1A-34BD-11651A3D7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4603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C4308D-1CCB-45D6-AEC0-9D9C05E57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E87382-6B46-D265-B3FC-7A5D50298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945AA6-8077-308D-1C54-5229CFC90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5837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7B408C-FC5A-D784-7727-4A0F2F6DE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A656E1-6B8B-D72A-D8D6-A3E9AD2428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1A376A-2C86-D393-5E89-797883F91B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5DB422-21F0-A62A-2D60-E5C6F6989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CD3803-F428-1858-3ACB-005A639ABA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0D3DF3-039A-FCAD-D419-11132F4B3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131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74A746-E33E-AF1C-633D-A0AA12C9AE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20A1C1-B65E-5916-6BFB-D8E85AAC0C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176DC3-E0B1-379A-9467-75A773CFC3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F7846E-2910-5607-0C59-60DDDE90B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EF4EC8-AD70-14E4-9B06-3574A4956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C2BB60-1CD9-3351-AC77-3C3840F07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1293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B32A0F-7891-4722-8303-2249BF1DB2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F5C959-EE0C-CDDC-5732-36700517F5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588EB9-DE25-051E-F2F9-41F0DD0E0D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025BAB-947E-D745-8C9C-4DD1EE9B2E42}" type="datetimeFigureOut">
              <a:rPr lang="en-US" smtClean="0"/>
              <a:t>9/22/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E3E0EC-0030-7D40-288D-8E31FE9318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BB020A-1307-3D83-07FB-337BE6FE10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769B8-DA46-1147-A4AD-B6C0FF31AAE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0378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black lines&#10;&#10;Description automatically generated">
            <a:extLst>
              <a:ext uri="{FF2B5EF4-FFF2-40B4-BE49-F238E27FC236}">
                <a16:creationId xmlns:a16="http://schemas.microsoft.com/office/drawing/2014/main" id="{44EB2D83-FED7-10C6-D2E8-4D8470541C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1295" y="0"/>
            <a:ext cx="3175000" cy="2832100"/>
          </a:xfrm>
          <a:prstGeom prst="rect">
            <a:avLst/>
          </a:prstGeom>
        </p:spPr>
      </p:pic>
      <p:pic>
        <p:nvPicPr>
          <p:cNvPr id="5" name="Picture 4" descr="A graph of different sizes and shapes&#10;&#10;Description automatically generated">
            <a:extLst>
              <a:ext uri="{FF2B5EF4-FFF2-40B4-BE49-F238E27FC236}">
                <a16:creationId xmlns:a16="http://schemas.microsoft.com/office/drawing/2014/main" id="{703400B9-CF81-09FF-78AD-1F6C7FD8F7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64144" y="143891"/>
            <a:ext cx="5295900" cy="27559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A7957FF-4A41-6813-E653-FF14DEBD4C6E}"/>
              </a:ext>
            </a:extLst>
          </p:cNvPr>
          <p:cNvSpPr txBox="1"/>
          <p:nvPr/>
        </p:nvSpPr>
        <p:spPr>
          <a:xfrm>
            <a:off x="2100222" y="2899791"/>
            <a:ext cx="57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4FE5188-25FE-3F49-30E3-61EF0E4D9425}"/>
              </a:ext>
            </a:extLst>
          </p:cNvPr>
          <p:cNvSpPr txBox="1"/>
          <p:nvPr/>
        </p:nvSpPr>
        <p:spPr>
          <a:xfrm>
            <a:off x="7736361" y="2989660"/>
            <a:ext cx="57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  <p:pic>
        <p:nvPicPr>
          <p:cNvPr id="9" name="Picture 8" descr="A graph of a number of different types of protein&#10;&#10;Description automatically generated">
            <a:extLst>
              <a:ext uri="{FF2B5EF4-FFF2-40B4-BE49-F238E27FC236}">
                <a16:creationId xmlns:a16="http://schemas.microsoft.com/office/drawing/2014/main" id="{9C1235BC-8883-09EC-95F0-DC5D229A5A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/>
          <a:stretch/>
        </p:blipFill>
        <p:spPr>
          <a:xfrm>
            <a:off x="889884" y="3248641"/>
            <a:ext cx="2996411" cy="2628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8FD4C47-774E-AAF3-CC89-2BDF88EC9323}"/>
              </a:ext>
            </a:extLst>
          </p:cNvPr>
          <p:cNvSpPr txBox="1"/>
          <p:nvPr/>
        </p:nvSpPr>
        <p:spPr>
          <a:xfrm>
            <a:off x="2512176" y="5873955"/>
            <a:ext cx="57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c)</a:t>
            </a:r>
          </a:p>
        </p:txBody>
      </p:sp>
      <p:pic>
        <p:nvPicPr>
          <p:cNvPr id="12" name="Picture 11" descr="A graph of a number of black and white bars&#10;&#10;Description automatically generated">
            <a:extLst>
              <a:ext uri="{FF2B5EF4-FFF2-40B4-BE49-F238E27FC236}">
                <a16:creationId xmlns:a16="http://schemas.microsoft.com/office/drawing/2014/main" id="{7D7A3874-64FF-E42C-C2FD-EED2D15328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92074" y="3142766"/>
            <a:ext cx="2717800" cy="2908300"/>
          </a:xfrm>
          <a:prstGeom prst="rect">
            <a:avLst/>
          </a:prstGeom>
        </p:spPr>
      </p:pic>
      <p:pic>
        <p:nvPicPr>
          <p:cNvPr id="14" name="Picture 13" descr="A graph of a graph of a certain amount of fat&#10;&#10;Description automatically generated">
            <a:extLst>
              <a:ext uri="{FF2B5EF4-FFF2-40B4-BE49-F238E27FC236}">
                <a16:creationId xmlns:a16="http://schemas.microsoft.com/office/drawing/2014/main" id="{BD5DAFAD-DB23-F252-DAA8-64C38A26BD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18578" y="3199916"/>
            <a:ext cx="2946400" cy="2794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2414C3D-8DA9-4BF7-C620-AE1AD2DC1790}"/>
              </a:ext>
            </a:extLst>
          </p:cNvPr>
          <p:cNvSpPr txBox="1"/>
          <p:nvPr/>
        </p:nvSpPr>
        <p:spPr>
          <a:xfrm>
            <a:off x="6111213" y="5972977"/>
            <a:ext cx="57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d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B5C2FFA-9809-00E2-B8F4-018FB21717EF}"/>
              </a:ext>
            </a:extLst>
          </p:cNvPr>
          <p:cNvSpPr txBox="1"/>
          <p:nvPr/>
        </p:nvSpPr>
        <p:spPr>
          <a:xfrm>
            <a:off x="10245311" y="5953023"/>
            <a:ext cx="575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e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A0E66A3-2F7F-F389-671E-A39468D65E4E}"/>
              </a:ext>
            </a:extLst>
          </p:cNvPr>
          <p:cNvSpPr txBox="1"/>
          <p:nvPr/>
        </p:nvSpPr>
        <p:spPr>
          <a:xfrm>
            <a:off x="98483" y="6234908"/>
            <a:ext cx="12104981" cy="10006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centrations of glucos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)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insulin; with </a:t>
            </a:r>
            <a:r>
              <a:rPr lang="en-CA" sz="1100" b="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CA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nificant differences between males and females at protein intakes 0.8 (*</a:t>
            </a:r>
            <a:r>
              <a:rPr lang="en-CA" sz="11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CA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0.0496), 1.3 (</a:t>
            </a:r>
            <a:r>
              <a:rPr lang="en-CA" sz="1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CA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CA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0.0398) and 1.5 (</a:t>
            </a:r>
            <a:r>
              <a:rPr lang="en-CA" sz="1100" dirty="0">
                <a:effectLst/>
                <a:latin typeface="Verdana" panose="020B060403050404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CA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CA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0.0249).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RP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intracellular GSH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urinary sulphat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cretion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US" sz="1100" b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older adults who participated in the study to </a:t>
            </a:r>
            <a:r>
              <a:rPr lang="en-CA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termine the minimum methionine requirement of adults </a:t>
            </a:r>
            <a:r>
              <a:rPr lang="en-CA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</a:t>
            </a:r>
            <a:r>
              <a:rPr lang="en-CA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0 y in good health</a:t>
            </a:r>
            <a:r>
              <a:rPr lang="en-CA" sz="11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CA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Bef>
                <a:spcPts val="1200"/>
              </a:spcBef>
            </a:pPr>
            <a:endParaRPr lang="en-CA" sz="11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236310F-0C37-88D0-BC1A-48E974D31B05}"/>
              </a:ext>
            </a:extLst>
          </p:cNvPr>
          <p:cNvSpPr txBox="1"/>
          <p:nvPr/>
        </p:nvSpPr>
        <p:spPr>
          <a:xfrm>
            <a:off x="1391046" y="2473209"/>
            <a:ext cx="2996411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Methionine intake, mg/kg/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E4B48DE-70DE-5F16-D96B-A07C4D9511E3}"/>
              </a:ext>
            </a:extLst>
          </p:cNvPr>
          <p:cNvSpPr txBox="1"/>
          <p:nvPr/>
        </p:nvSpPr>
        <p:spPr>
          <a:xfrm>
            <a:off x="6747392" y="2620740"/>
            <a:ext cx="2996411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Methionine intake, mg/kg/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D9D860-432D-CCF4-ABFB-D41E76920574}"/>
              </a:ext>
            </a:extLst>
          </p:cNvPr>
          <p:cNvSpPr txBox="1"/>
          <p:nvPr/>
        </p:nvSpPr>
        <p:spPr>
          <a:xfrm>
            <a:off x="5209146" y="5608544"/>
            <a:ext cx="2996411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Methionine intake, mg/kg/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35643C-E1E7-EBFD-B095-4CE1DAE601F4}"/>
              </a:ext>
            </a:extLst>
          </p:cNvPr>
          <p:cNvSpPr txBox="1"/>
          <p:nvPr/>
        </p:nvSpPr>
        <p:spPr>
          <a:xfrm>
            <a:off x="9322838" y="5635390"/>
            <a:ext cx="2655161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Methionine intake, mg/kg/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6525D22-8F70-CF75-CF41-0D3646A2D85D}"/>
              </a:ext>
            </a:extLst>
          </p:cNvPr>
          <p:cNvSpPr txBox="1"/>
          <p:nvPr/>
        </p:nvSpPr>
        <p:spPr>
          <a:xfrm>
            <a:off x="1589703" y="5527185"/>
            <a:ext cx="2996411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Methionine intake, mg/kg/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12C06CA-2D6D-6F8D-E7B2-E534B4B5BAA2}"/>
              </a:ext>
            </a:extLst>
          </p:cNvPr>
          <p:cNvSpPr txBox="1"/>
          <p:nvPr/>
        </p:nvSpPr>
        <p:spPr>
          <a:xfrm rot="16200000">
            <a:off x="222465" y="1084727"/>
            <a:ext cx="1611837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Glucose, mmol/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8701288-531D-D249-0556-8C1C75A92D37}"/>
              </a:ext>
            </a:extLst>
          </p:cNvPr>
          <p:cNvSpPr txBox="1"/>
          <p:nvPr/>
        </p:nvSpPr>
        <p:spPr>
          <a:xfrm rot="16200000">
            <a:off x="5151582" y="1084727"/>
            <a:ext cx="1611837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Insulin, pmol/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FF69114-437E-2C22-E35F-CEB964535985}"/>
              </a:ext>
            </a:extLst>
          </p:cNvPr>
          <p:cNvSpPr txBox="1"/>
          <p:nvPr/>
        </p:nvSpPr>
        <p:spPr>
          <a:xfrm rot="16200000">
            <a:off x="79422" y="3962956"/>
            <a:ext cx="2378899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C-reactive protein, mg/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C3A31C9-FBEE-4E1A-FEED-9C94B70AFFF4}"/>
              </a:ext>
            </a:extLst>
          </p:cNvPr>
          <p:cNvSpPr txBox="1"/>
          <p:nvPr/>
        </p:nvSpPr>
        <p:spPr>
          <a:xfrm rot="16200000">
            <a:off x="3504067" y="4220007"/>
            <a:ext cx="2830338" cy="26161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Erythrocyte GSH concentration, mmol/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B283F0F-0997-5870-B1D3-A1A530D0383D}"/>
              </a:ext>
            </a:extLst>
          </p:cNvPr>
          <p:cNvSpPr txBox="1"/>
          <p:nvPr/>
        </p:nvSpPr>
        <p:spPr>
          <a:xfrm rot="16200000">
            <a:off x="7065747" y="3987525"/>
            <a:ext cx="3495861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Sulphate excretion,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µmol/µmol</a:t>
            </a:r>
            <a:r>
              <a:rPr lang="en-US" sz="1200" b="1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reatinine</a:t>
            </a:r>
            <a:r>
              <a:rPr lang="en-CA" sz="1200" b="1" dirty="0">
                <a:effectLst/>
                <a:latin typeface="Palatino Linotype" panose="02040502050505030304" pitchFamily="18" charset="0"/>
              </a:rPr>
              <a:t> </a:t>
            </a:r>
            <a:endParaRPr lang="en-US" sz="12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4855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65</Words>
  <Application>Microsoft Macintosh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Verdan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yssa Paoletti</dc:creator>
  <cp:lastModifiedBy>Alyssa Paoletti</cp:lastModifiedBy>
  <cp:revision>21</cp:revision>
  <cp:lastPrinted>2023-09-22T12:10:07Z</cp:lastPrinted>
  <dcterms:created xsi:type="dcterms:W3CDTF">2023-06-29T15:08:07Z</dcterms:created>
  <dcterms:modified xsi:type="dcterms:W3CDTF">2023-09-22T22:41:24Z</dcterms:modified>
</cp:coreProperties>
</file>